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BAAF182-003B-418F-9184-AE65B6E04824}" v="1" dt="2025-12-18T15:46:11.83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97" d="100"/>
          <a:sy n="97" d="100"/>
        </p:scale>
        <p:origin x="1110" y="3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ernanda Cabral" userId="42d50efda94ffcc9" providerId="LiveId" clId="{240AC63F-B80A-40CF-94A8-DEB1A837517D}"/>
    <pc:docChg chg="modSld">
      <pc:chgData name="Fernanda Cabral" userId="42d50efda94ffcc9" providerId="LiveId" clId="{240AC63F-B80A-40CF-94A8-DEB1A837517D}" dt="2025-12-18T16:27:15.872" v="37" actId="14100"/>
      <pc:docMkLst>
        <pc:docMk/>
      </pc:docMkLst>
      <pc:sldChg chg="modSp mod">
        <pc:chgData name="Fernanda Cabral" userId="42d50efda94ffcc9" providerId="LiveId" clId="{240AC63F-B80A-40CF-94A8-DEB1A837517D}" dt="2025-12-18T16:27:15.872" v="37" actId="14100"/>
        <pc:sldMkLst>
          <pc:docMk/>
          <pc:sldMk cId="430095387" sldId="256"/>
        </pc:sldMkLst>
        <pc:spChg chg="mod">
          <ac:chgData name="Fernanda Cabral" userId="42d50efda94ffcc9" providerId="LiveId" clId="{240AC63F-B80A-40CF-94A8-DEB1A837517D}" dt="2025-12-18T16:27:15.872" v="37" actId="14100"/>
          <ac:spMkLst>
            <pc:docMk/>
            <pc:sldMk cId="430095387" sldId="256"/>
            <ac:spMk id="5" creationId="{FE338E5F-8A1C-96BF-DA18-11F28482DBFA}"/>
          </ac:spMkLst>
        </pc:spChg>
        <pc:picChg chg="mod">
          <ac:chgData name="Fernanda Cabral" userId="42d50efda94ffcc9" providerId="LiveId" clId="{240AC63F-B80A-40CF-94A8-DEB1A837517D}" dt="2025-12-18T15:46:04.606" v="14" actId="1076"/>
          <ac:picMkLst>
            <pc:docMk/>
            <pc:sldMk cId="430095387" sldId="256"/>
            <ac:picMk id="4" creationId="{037ABE3E-28AD-EFF9-8A00-AB58770829B8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F7D4A44-F718-F3B9-7F42-276E8E298BB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CC3AD016-C95D-03F5-D24E-4B2832E2AA1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28A8D411-C3E4-F9FE-C5B4-4B2A7B19D3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5A830-3C19-4678-ACFB-44D847A412B5}" type="datetimeFigureOut">
              <a:rPr lang="pt-BR" smtClean="0"/>
              <a:t>18/12/2025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7C67116B-23A8-E8C3-CA67-840E256B0C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71C5047D-8F85-01DE-AA17-07BD0D5FF2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C57D1-2FD0-4F2D-8CF4-BB377BEDD5B7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8106044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B9E631D-F667-34BF-367A-BDD1782B20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FBF95618-1A07-7479-EA0A-0BFE5ACDE1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A3805522-387A-6E2A-552F-67F9D2C4C8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5A830-3C19-4678-ACFB-44D847A412B5}" type="datetimeFigureOut">
              <a:rPr lang="pt-BR" smtClean="0"/>
              <a:t>18/12/2025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1D6A202B-AF10-BDE1-5250-E7803A021A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074E8FE5-63CD-E193-E39A-C5E2A07BF2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C57D1-2FD0-4F2D-8CF4-BB377BEDD5B7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8399281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B7514068-882C-9EDE-D840-D2F20CD4D54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093A9019-376B-4BB8-7305-013939559C0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F6DBD22A-80FB-08B9-7476-BB001BE7D7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5A830-3C19-4678-ACFB-44D847A412B5}" type="datetimeFigureOut">
              <a:rPr lang="pt-BR" smtClean="0"/>
              <a:t>18/12/2025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2A905E64-E8F1-B850-F2A3-BB7000656A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1B29B8DA-32D8-0B01-D35F-087F5E0694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C57D1-2FD0-4F2D-8CF4-BB377BEDD5B7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5351662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FDA59A9-2F5B-CF43-588C-670DE5B0E3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42C38F2F-5445-0073-BC14-0327A5827FA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44C6B3B1-D2FB-4FFB-639A-46072F3F54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5A830-3C19-4678-ACFB-44D847A412B5}" type="datetimeFigureOut">
              <a:rPr lang="pt-BR" smtClean="0"/>
              <a:t>18/12/2025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B5CC8BED-C215-5847-4926-9CB45FB18E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5D08E749-BF6B-13BB-303C-84B942F05C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C57D1-2FD0-4F2D-8CF4-BB377BEDD5B7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653806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51C69AF-F31A-5BED-186F-36D9785707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73FC8CFE-AA02-D374-2525-8A06648679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63F6D0E7-EACD-3A7B-32AF-446CD7BE97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5A830-3C19-4678-ACFB-44D847A412B5}" type="datetimeFigureOut">
              <a:rPr lang="pt-BR" smtClean="0"/>
              <a:t>18/12/2025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FDE99D8F-AB8D-7C7A-0DF6-2911F9CFE7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C093C5E3-6FEA-96E5-043F-1BB0BA81E3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C57D1-2FD0-4F2D-8CF4-BB377BEDD5B7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3245450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0AC9762-79CB-EB11-07E2-D59517DD6D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57723B47-C167-B850-D3E2-3F6B85D7E05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6EEA838A-5807-4F83-70EE-BBB5CC71C85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48FCE3DC-5DCB-B845-252D-913F1D9DD7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5A830-3C19-4678-ACFB-44D847A412B5}" type="datetimeFigureOut">
              <a:rPr lang="pt-BR" smtClean="0"/>
              <a:t>18/12/2025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34EAAC8B-DF28-CC60-EB15-6269A09FD7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41628975-80AD-A887-89D4-6A8EBB96A8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C57D1-2FD0-4F2D-8CF4-BB377BEDD5B7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4700827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482E7A7-48B1-837D-0E02-32B106E18F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B9109272-4C6A-95DF-31CC-3A3845314F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08C3E44E-4BFB-EB5E-D7D0-956552FDC00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>
            <a:extLst>
              <a:ext uri="{FF2B5EF4-FFF2-40B4-BE49-F238E27FC236}">
                <a16:creationId xmlns:a16="http://schemas.microsoft.com/office/drawing/2014/main" id="{8CA1E29D-3B28-9343-E1C0-60824D780F1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Espaço Reservado para Conteúdo 5">
            <a:extLst>
              <a:ext uri="{FF2B5EF4-FFF2-40B4-BE49-F238E27FC236}">
                <a16:creationId xmlns:a16="http://schemas.microsoft.com/office/drawing/2014/main" id="{1B6C87D4-2F6E-205D-4A5B-7CCA068C860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>
            <a:extLst>
              <a:ext uri="{FF2B5EF4-FFF2-40B4-BE49-F238E27FC236}">
                <a16:creationId xmlns:a16="http://schemas.microsoft.com/office/drawing/2014/main" id="{1B7A4494-C887-3013-C550-ABAE83FAAE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5A830-3C19-4678-ACFB-44D847A412B5}" type="datetimeFigureOut">
              <a:rPr lang="pt-BR" smtClean="0"/>
              <a:t>18/12/2025</a:t>
            </a:fld>
            <a:endParaRPr lang="pt-BR"/>
          </a:p>
        </p:txBody>
      </p:sp>
      <p:sp>
        <p:nvSpPr>
          <p:cNvPr id="8" name="Espaço Reservado para Rodapé 7">
            <a:extLst>
              <a:ext uri="{FF2B5EF4-FFF2-40B4-BE49-F238E27FC236}">
                <a16:creationId xmlns:a16="http://schemas.microsoft.com/office/drawing/2014/main" id="{11216DDC-F448-787D-0EB7-15B4B5DE35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>
            <a:extLst>
              <a:ext uri="{FF2B5EF4-FFF2-40B4-BE49-F238E27FC236}">
                <a16:creationId xmlns:a16="http://schemas.microsoft.com/office/drawing/2014/main" id="{4A43F25F-E5DB-2B7E-0885-916A9B406C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C57D1-2FD0-4F2D-8CF4-BB377BEDD5B7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0023397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43429E6-18A1-9E16-AFEA-D712FE339C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71878E79-9050-7482-2FD5-C3452CC2B0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5A830-3C19-4678-ACFB-44D847A412B5}" type="datetimeFigureOut">
              <a:rPr lang="pt-BR" smtClean="0"/>
              <a:t>18/12/2025</a:t>
            </a:fld>
            <a:endParaRPr lang="pt-BR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C9550ABA-6542-B1BB-FB9E-6D5D46E925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E17615DE-133F-7B44-FB00-B74F5A84C0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C57D1-2FD0-4F2D-8CF4-BB377BEDD5B7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9655309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>
            <a:extLst>
              <a:ext uri="{FF2B5EF4-FFF2-40B4-BE49-F238E27FC236}">
                <a16:creationId xmlns:a16="http://schemas.microsoft.com/office/drawing/2014/main" id="{29827BFB-20E4-EC74-2CFE-930318ED0A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5A830-3C19-4678-ACFB-44D847A412B5}" type="datetimeFigureOut">
              <a:rPr lang="pt-BR" smtClean="0"/>
              <a:t>18/12/2025</a:t>
            </a:fld>
            <a:endParaRPr lang="pt-BR"/>
          </a:p>
        </p:txBody>
      </p:sp>
      <p:sp>
        <p:nvSpPr>
          <p:cNvPr id="3" name="Espaço Reservado para Rodapé 2">
            <a:extLst>
              <a:ext uri="{FF2B5EF4-FFF2-40B4-BE49-F238E27FC236}">
                <a16:creationId xmlns:a16="http://schemas.microsoft.com/office/drawing/2014/main" id="{21A2955E-E994-6F68-F253-D98A8C15DF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08D919E6-7277-64F5-B0F4-7447E3F39E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C57D1-2FD0-4F2D-8CF4-BB377BEDD5B7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6481777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CD661AC-A1A0-5227-C544-F43B268AFC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C1661E0B-8529-C347-FA81-E2D700C925D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DC7C4F8D-6BCD-6ECC-CF15-EC2AB5C7D36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A68BC54D-B8E5-296D-A715-FBB89CBE84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5A830-3C19-4678-ACFB-44D847A412B5}" type="datetimeFigureOut">
              <a:rPr lang="pt-BR" smtClean="0"/>
              <a:t>18/12/2025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A52B5A55-EDD1-536B-067C-C7ACC38911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23B5638F-48F8-ED5E-3E97-7FC7AF178D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C57D1-2FD0-4F2D-8CF4-BB377BEDD5B7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8855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FDA6EEB-D904-BA82-B448-8F818859EB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>
            <a:extLst>
              <a:ext uri="{FF2B5EF4-FFF2-40B4-BE49-F238E27FC236}">
                <a16:creationId xmlns:a16="http://schemas.microsoft.com/office/drawing/2014/main" id="{299E6B16-5BB9-6E55-C92C-21F3C23681E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97230317-FDCB-CF04-BD06-BF8D08EFB3D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A95F36BD-516B-AE69-B58C-C5CEBDEF2B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45A830-3C19-4678-ACFB-44D847A412B5}" type="datetimeFigureOut">
              <a:rPr lang="pt-BR" smtClean="0"/>
              <a:t>18/12/2025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EBFCB9D1-CC24-33C1-CE28-70DF2D42C8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6687FD37-A501-6F82-9523-AAB5592BD5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6C57D1-2FD0-4F2D-8CF4-BB377BEDD5B7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546669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>
            <a:extLst>
              <a:ext uri="{FF2B5EF4-FFF2-40B4-BE49-F238E27FC236}">
                <a16:creationId xmlns:a16="http://schemas.microsoft.com/office/drawing/2014/main" id="{304C38AC-88B2-BBF8-787A-3F24C301D8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A1E23D31-0F2F-D6E1-DC7D-DDA6F1DD82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15BCD62E-293B-39EB-1298-4CBA26C001F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745A830-3C19-4678-ACFB-44D847A412B5}" type="datetimeFigureOut">
              <a:rPr lang="pt-BR" smtClean="0"/>
              <a:t>18/12/2025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8AEB4C69-A74B-5814-6FD7-CD0F3809F37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A475A178-838B-C9B3-94FD-73274D3752B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46C57D1-2FD0-4F2D-8CF4-BB377BEDD5B7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9900823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m 3">
            <a:extLst>
              <a:ext uri="{FF2B5EF4-FFF2-40B4-BE49-F238E27FC236}">
                <a16:creationId xmlns:a16="http://schemas.microsoft.com/office/drawing/2014/main" id="{037ABE3E-28AD-EFF9-8A00-AB58770829B8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982"/>
          <a:stretch/>
        </p:blipFill>
        <p:spPr>
          <a:xfrm>
            <a:off x="643467" y="201196"/>
            <a:ext cx="10905066" cy="4862781"/>
          </a:xfrm>
          <a:prstGeom prst="rect">
            <a:avLst/>
          </a:prstGeom>
        </p:spPr>
      </p:pic>
      <p:sp>
        <p:nvSpPr>
          <p:cNvPr id="5" name="CaixaDeTexto 4">
            <a:extLst>
              <a:ext uri="{FF2B5EF4-FFF2-40B4-BE49-F238E27FC236}">
                <a16:creationId xmlns:a16="http://schemas.microsoft.com/office/drawing/2014/main" id="{FE338E5F-8A1C-96BF-DA18-11F28482DBFA}"/>
              </a:ext>
            </a:extLst>
          </p:cNvPr>
          <p:cNvSpPr txBox="1"/>
          <p:nvPr/>
        </p:nvSpPr>
        <p:spPr>
          <a:xfrm>
            <a:off x="3244645" y="5063977"/>
            <a:ext cx="566338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dirty="0" err="1"/>
              <a:t>Supplementary</a:t>
            </a:r>
            <a:r>
              <a:rPr lang="pt-BR" dirty="0"/>
              <a:t> Fig. 1: </a:t>
            </a:r>
            <a:r>
              <a:rPr lang="en-US" dirty="0"/>
              <a:t>Comparison of the body weight of the infected animal (red bar) with the body weight of the control animal (CTRL) (blue bar).</a:t>
            </a:r>
            <a:endParaRPr lang="pt-BR" dirty="0"/>
          </a:p>
        </p:txBody>
      </p:sp>
    </p:spTree>
    <p:extLst>
      <p:ext uri="{BB962C8B-B14F-4D97-AF65-F5344CB8AC3E}">
        <p14:creationId xmlns:p14="http://schemas.microsoft.com/office/powerpoint/2010/main" val="43009538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2</TotalTime>
  <Words>33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Fernanda Cabral</dc:creator>
  <cp:lastModifiedBy>Fernanda Cabral</cp:lastModifiedBy>
  <cp:revision>1</cp:revision>
  <dcterms:created xsi:type="dcterms:W3CDTF">2025-10-30T13:37:15Z</dcterms:created>
  <dcterms:modified xsi:type="dcterms:W3CDTF">2025-12-18T16:27:19Z</dcterms:modified>
</cp:coreProperties>
</file>